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58" r:id="rId1"/>
    <p:sldMasterId id="2147483870" r:id="rId2"/>
  </p:sldMasterIdLst>
  <p:sldIdLst>
    <p:sldId id="268" r:id="rId3"/>
    <p:sldId id="269" r:id="rId4"/>
    <p:sldId id="257" r:id="rId5"/>
    <p:sldId id="258" r:id="rId6"/>
    <p:sldId id="259" r:id="rId7"/>
    <p:sldId id="266" r:id="rId8"/>
    <p:sldId id="261" r:id="rId9"/>
    <p:sldId id="262" r:id="rId10"/>
    <p:sldId id="267" r:id="rId11"/>
    <p:sldId id="264" r:id="rId12"/>
    <p:sldId id="265" r:id="rId13"/>
    <p:sldId id="271" r:id="rId14"/>
    <p:sldId id="270" r:id="rId15"/>
    <p:sldId id="272" r:id="rId16"/>
    <p:sldId id="273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42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55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presProps" Target="presProps.xml"/><Relationship Id="rId3" Type="http://schemas.openxmlformats.org/officeDocument/2006/relationships/slide" Target="slides/slide1.xml"/><Relationship Id="rId21" Type="http://schemas.openxmlformats.org/officeDocument/2006/relationships/tableStyles" Target="tableStyles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Molecular-think\d\Shrutikaa\DBS\DBS_analysis%20(Autosaved)%20(Autosaved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u="none" strike="noStrike" baseline="0" dirty="0" smtClean="0">
                <a:effectLst/>
              </a:rPr>
              <a:t> Graphical representation of the coverage statistics 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I$2</c:f>
              <c:strCache>
                <c:ptCount val="1"/>
                <c:pt idx="0">
                  <c:v>DB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H$3:$H$26</c:f>
              <c:strCache>
                <c:ptCount val="24"/>
                <c:pt idx="0">
                  <c:v>0-50</c:v>
                </c:pt>
                <c:pt idx="1">
                  <c:v>51-100</c:v>
                </c:pt>
                <c:pt idx="2">
                  <c:v>101-150</c:v>
                </c:pt>
                <c:pt idx="3">
                  <c:v>151-200</c:v>
                </c:pt>
                <c:pt idx="4">
                  <c:v>201-250</c:v>
                </c:pt>
                <c:pt idx="5">
                  <c:v>251-300</c:v>
                </c:pt>
                <c:pt idx="6">
                  <c:v>301-350</c:v>
                </c:pt>
                <c:pt idx="7">
                  <c:v>351-400</c:v>
                </c:pt>
                <c:pt idx="8">
                  <c:v>401-450</c:v>
                </c:pt>
                <c:pt idx="9">
                  <c:v>451-500</c:v>
                </c:pt>
                <c:pt idx="10">
                  <c:v>501-550</c:v>
                </c:pt>
                <c:pt idx="11">
                  <c:v>551-600</c:v>
                </c:pt>
                <c:pt idx="12">
                  <c:v>601-650</c:v>
                </c:pt>
                <c:pt idx="13">
                  <c:v>651-700</c:v>
                </c:pt>
                <c:pt idx="14">
                  <c:v>701-750</c:v>
                </c:pt>
                <c:pt idx="15">
                  <c:v>751-800</c:v>
                </c:pt>
                <c:pt idx="16">
                  <c:v>801-850</c:v>
                </c:pt>
                <c:pt idx="17">
                  <c:v>851-900</c:v>
                </c:pt>
                <c:pt idx="18">
                  <c:v>901-950</c:v>
                </c:pt>
                <c:pt idx="19">
                  <c:v>951-1000</c:v>
                </c:pt>
                <c:pt idx="20">
                  <c:v>1001-1050</c:v>
                </c:pt>
                <c:pt idx="21">
                  <c:v>1051-1100</c:v>
                </c:pt>
                <c:pt idx="22">
                  <c:v>1101-1150</c:v>
                </c:pt>
                <c:pt idx="23">
                  <c:v>1151-1200</c:v>
                </c:pt>
              </c:strCache>
            </c:strRef>
          </c:cat>
          <c:val>
            <c:numRef>
              <c:f>Sheet1!$I$3:$I$26</c:f>
              <c:numCache>
                <c:formatCode>General</c:formatCode>
                <c:ptCount val="24"/>
                <c:pt idx="0">
                  <c:v>248</c:v>
                </c:pt>
                <c:pt idx="1">
                  <c:v>167</c:v>
                </c:pt>
                <c:pt idx="2">
                  <c:v>109</c:v>
                </c:pt>
                <c:pt idx="3">
                  <c:v>117</c:v>
                </c:pt>
                <c:pt idx="4">
                  <c:v>65</c:v>
                </c:pt>
                <c:pt idx="5">
                  <c:v>54</c:v>
                </c:pt>
                <c:pt idx="6">
                  <c:v>33</c:v>
                </c:pt>
                <c:pt idx="7">
                  <c:v>36</c:v>
                </c:pt>
                <c:pt idx="8">
                  <c:v>17</c:v>
                </c:pt>
                <c:pt idx="9">
                  <c:v>19</c:v>
                </c:pt>
                <c:pt idx="10">
                  <c:v>15</c:v>
                </c:pt>
                <c:pt idx="11">
                  <c:v>15</c:v>
                </c:pt>
                <c:pt idx="12">
                  <c:v>2</c:v>
                </c:pt>
                <c:pt idx="13">
                  <c:v>2</c:v>
                </c:pt>
                <c:pt idx="14">
                  <c:v>3</c:v>
                </c:pt>
                <c:pt idx="15">
                  <c:v>0</c:v>
                </c:pt>
                <c:pt idx="16">
                  <c:v>0</c:v>
                </c:pt>
                <c:pt idx="17">
                  <c:v>1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6D-4884-9899-6B24DF665FF1}"/>
            </c:ext>
          </c:extLst>
        </c:ser>
        <c:ser>
          <c:idx val="1"/>
          <c:order val="1"/>
          <c:tx>
            <c:strRef>
              <c:f>Sheet1!$J$2</c:f>
              <c:strCache>
                <c:ptCount val="1"/>
                <c:pt idx="0">
                  <c:v>Previo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H$3:$H$26</c:f>
              <c:strCache>
                <c:ptCount val="24"/>
                <c:pt idx="0">
                  <c:v>0-50</c:v>
                </c:pt>
                <c:pt idx="1">
                  <c:v>51-100</c:v>
                </c:pt>
                <c:pt idx="2">
                  <c:v>101-150</c:v>
                </c:pt>
                <c:pt idx="3">
                  <c:v>151-200</c:v>
                </c:pt>
                <c:pt idx="4">
                  <c:v>201-250</c:v>
                </c:pt>
                <c:pt idx="5">
                  <c:v>251-300</c:v>
                </c:pt>
                <c:pt idx="6">
                  <c:v>301-350</c:v>
                </c:pt>
                <c:pt idx="7">
                  <c:v>351-400</c:v>
                </c:pt>
                <c:pt idx="8">
                  <c:v>401-450</c:v>
                </c:pt>
                <c:pt idx="9">
                  <c:v>451-500</c:v>
                </c:pt>
                <c:pt idx="10">
                  <c:v>501-550</c:v>
                </c:pt>
                <c:pt idx="11">
                  <c:v>551-600</c:v>
                </c:pt>
                <c:pt idx="12">
                  <c:v>601-650</c:v>
                </c:pt>
                <c:pt idx="13">
                  <c:v>651-700</c:v>
                </c:pt>
                <c:pt idx="14">
                  <c:v>701-750</c:v>
                </c:pt>
                <c:pt idx="15">
                  <c:v>751-800</c:v>
                </c:pt>
                <c:pt idx="16">
                  <c:v>801-850</c:v>
                </c:pt>
                <c:pt idx="17">
                  <c:v>851-900</c:v>
                </c:pt>
                <c:pt idx="18">
                  <c:v>901-950</c:v>
                </c:pt>
                <c:pt idx="19">
                  <c:v>951-1000</c:v>
                </c:pt>
                <c:pt idx="20">
                  <c:v>1001-1050</c:v>
                </c:pt>
                <c:pt idx="21">
                  <c:v>1051-1100</c:v>
                </c:pt>
                <c:pt idx="22">
                  <c:v>1101-1150</c:v>
                </c:pt>
                <c:pt idx="23">
                  <c:v>1151-1200</c:v>
                </c:pt>
              </c:strCache>
            </c:strRef>
          </c:cat>
          <c:val>
            <c:numRef>
              <c:f>Sheet1!$J$3:$J$26</c:f>
              <c:numCache>
                <c:formatCode>General</c:formatCode>
                <c:ptCount val="24"/>
                <c:pt idx="0">
                  <c:v>150</c:v>
                </c:pt>
                <c:pt idx="1">
                  <c:v>121</c:v>
                </c:pt>
                <c:pt idx="2">
                  <c:v>111</c:v>
                </c:pt>
                <c:pt idx="3">
                  <c:v>74</c:v>
                </c:pt>
                <c:pt idx="4">
                  <c:v>60</c:v>
                </c:pt>
                <c:pt idx="5">
                  <c:v>84</c:v>
                </c:pt>
                <c:pt idx="6">
                  <c:v>57</c:v>
                </c:pt>
                <c:pt idx="7">
                  <c:v>42</c:v>
                </c:pt>
                <c:pt idx="8">
                  <c:v>42</c:v>
                </c:pt>
                <c:pt idx="9">
                  <c:v>25</c:v>
                </c:pt>
                <c:pt idx="10">
                  <c:v>29</c:v>
                </c:pt>
                <c:pt idx="11">
                  <c:v>27</c:v>
                </c:pt>
                <c:pt idx="12">
                  <c:v>16</c:v>
                </c:pt>
                <c:pt idx="13">
                  <c:v>20</c:v>
                </c:pt>
                <c:pt idx="14">
                  <c:v>10</c:v>
                </c:pt>
                <c:pt idx="15">
                  <c:v>3</c:v>
                </c:pt>
                <c:pt idx="16">
                  <c:v>10</c:v>
                </c:pt>
                <c:pt idx="17">
                  <c:v>3</c:v>
                </c:pt>
                <c:pt idx="18">
                  <c:v>8</c:v>
                </c:pt>
                <c:pt idx="19">
                  <c:v>4</c:v>
                </c:pt>
                <c:pt idx="20">
                  <c:v>2</c:v>
                </c:pt>
                <c:pt idx="21">
                  <c:v>1</c:v>
                </c:pt>
                <c:pt idx="22">
                  <c:v>2</c:v>
                </c:pt>
                <c:pt idx="2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6D-4884-9899-6B24DF665F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974056"/>
        <c:axId val="424975040"/>
      </c:barChart>
      <c:catAx>
        <c:axId val="424974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975040"/>
        <c:crosses val="autoZero"/>
        <c:auto val="1"/>
        <c:lblAlgn val="ctr"/>
        <c:lblOffset val="100"/>
        <c:noMultiLvlLbl val="0"/>
      </c:catAx>
      <c:valAx>
        <c:axId val="424975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9740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30247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137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143536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31749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87664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14312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94455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41123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64016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07373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740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83068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54344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45346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103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238474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31173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0588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101978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015709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6127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390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43706-6C4A-4ED8-8895-7FB66AEAA560}" type="datetimeFigureOut">
              <a:rPr lang="en-GB" smtClean="0"/>
              <a:t>1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CC030-83E2-45DD-8A81-755947844FA7}" type="slidenum">
              <a:rPr lang="en-GB" smtClean="0"/>
              <a:t>‹#›</a:t>
            </a:fld>
            <a:endParaRPr lang="en-GB"/>
          </a:p>
        </p:txBody>
      </p:sp>
      <p:sp>
        <p:nvSpPr>
          <p:cNvPr id="7" name="Rectangle 6"/>
          <p:cNvSpPr/>
          <p:nvPr userDrawn="1"/>
        </p:nvSpPr>
        <p:spPr>
          <a:xfrm>
            <a:off x="3657600" y="6445045"/>
            <a:ext cx="4940709" cy="25072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CONFIDENTIAL BY INSTITUTE OF HUMAN GENETICS</a:t>
            </a:r>
            <a:endParaRPr 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68388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59" r:id="rId1"/>
    <p:sldLayoutId id="2147483860" r:id="rId2"/>
    <p:sldLayoutId id="2147483861" r:id="rId3"/>
    <p:sldLayoutId id="2147483862" r:id="rId4"/>
    <p:sldLayoutId id="2147483863" r:id="rId5"/>
    <p:sldLayoutId id="2147483864" r:id="rId6"/>
    <p:sldLayoutId id="2147483865" r:id="rId7"/>
    <p:sldLayoutId id="2147483866" r:id="rId8"/>
    <p:sldLayoutId id="2147483867" r:id="rId9"/>
    <p:sldLayoutId id="2147483868" r:id="rId10"/>
    <p:sldLayoutId id="2147483869" r:id="rId11"/>
  </p:sldLayoutIdLs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86736-F4F7-4CA2-8782-DC88AAFFBD00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1BBC3A-1112-4006-839B-D6BC5030E2F7}" type="slidenum">
              <a:rPr lang="en-US" smtClean="0"/>
              <a:t>‹#›</a:t>
            </a:fld>
            <a:endParaRPr lang="en-US"/>
          </a:p>
        </p:txBody>
      </p:sp>
      <p:sp>
        <p:nvSpPr>
          <p:cNvPr id="8" name="Rectangle 7"/>
          <p:cNvSpPr/>
          <p:nvPr userDrawn="1"/>
        </p:nvSpPr>
        <p:spPr>
          <a:xfrm>
            <a:off x="3657600" y="6223819"/>
            <a:ext cx="4955459" cy="51619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CONFIDENTIAL BY INSTITUTE OF HUMAN GENETICS</a:t>
            </a:r>
            <a:endParaRPr 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5002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1" r:id="rId1"/>
    <p:sldLayoutId id="2147483872" r:id="rId2"/>
    <p:sldLayoutId id="2147483873" r:id="rId3"/>
    <p:sldLayoutId id="2147483874" r:id="rId4"/>
    <p:sldLayoutId id="2147483875" r:id="rId5"/>
    <p:sldLayoutId id="2147483876" r:id="rId6"/>
    <p:sldLayoutId id="2147483877" r:id="rId7"/>
    <p:sldLayoutId id="2147483878" r:id="rId8"/>
    <p:sldLayoutId id="2147483879" r:id="rId9"/>
    <p:sldLayoutId id="2147483880" r:id="rId10"/>
    <p:sldLayoutId id="2147483881" r:id="rId11"/>
  </p:sldLayoutIdLs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66800" y="3429000"/>
            <a:ext cx="10058400" cy="896112"/>
          </a:xfrm>
        </p:spPr>
        <p:txBody>
          <a:bodyPr>
            <a:normAutofit/>
          </a:bodyPr>
          <a:lstStyle/>
          <a:p>
            <a:r>
              <a:rPr lang="en-US" sz="2400" b="1" dirty="0" smtClean="0"/>
              <a:t>Comparative data for Dried Blood Spot (DBS) extracted DNA and Manual blood extracted DNA </a:t>
            </a:r>
            <a:endParaRPr lang="en-US" sz="2400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89913" y="5677470"/>
            <a:ext cx="2470247" cy="641445"/>
          </a:xfrm>
        </p:spPr>
        <p:txBody>
          <a:bodyPr>
            <a:noAutofit/>
          </a:bodyPr>
          <a:lstStyle/>
          <a:p>
            <a:r>
              <a:rPr lang="en-US" sz="1600" b="1" dirty="0" smtClean="0"/>
              <a:t>Shrutikaa Kale</a:t>
            </a:r>
          </a:p>
          <a:p>
            <a:r>
              <a:rPr lang="en-US" sz="1200" b="1" dirty="0" smtClean="0"/>
              <a:t>Junior Research fellow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8762927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239" y="54593"/>
            <a:ext cx="5751536" cy="326181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239" y="3429001"/>
            <a:ext cx="5751536" cy="306029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71158" y="54593"/>
            <a:ext cx="5591175" cy="326181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66609" y="3429000"/>
            <a:ext cx="5591175" cy="301604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528547" y="124779"/>
            <a:ext cx="3411941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BLOOD </a:t>
            </a:r>
            <a:endParaRPr lang="en-GB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952947" y="99433"/>
            <a:ext cx="2695787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DBS </a:t>
            </a:r>
            <a:endParaRPr lang="en-GB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07987" y="3429823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BLOOD (0-50X)</a:t>
            </a:r>
            <a:endParaRPr lang="en-GB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456236" y="3473039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DBS (0-50X)</a:t>
            </a:r>
            <a:endParaRPr lang="en-GB" sz="1400" b="1" dirty="0"/>
          </a:p>
        </p:txBody>
      </p:sp>
      <p:sp>
        <p:nvSpPr>
          <p:cNvPr id="12" name="Rectangle 11"/>
          <p:cNvSpPr/>
          <p:nvPr/>
        </p:nvSpPr>
        <p:spPr>
          <a:xfrm>
            <a:off x="4285397" y="432556"/>
            <a:ext cx="218364" cy="278831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10033396" y="434828"/>
            <a:ext cx="218364" cy="278831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/>
          <p:cNvSpPr txBox="1"/>
          <p:nvPr/>
        </p:nvSpPr>
        <p:spPr>
          <a:xfrm>
            <a:off x="268408" y="83836"/>
            <a:ext cx="714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439791" y="114613"/>
            <a:ext cx="820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52477" y="3499580"/>
            <a:ext cx="725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6421265" y="3485932"/>
            <a:ext cx="79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4148185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378" y="40945"/>
            <a:ext cx="5619750" cy="328911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378" y="3429001"/>
            <a:ext cx="5591175" cy="30307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34978" y="40945"/>
            <a:ext cx="5581650" cy="328911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34978" y="3432412"/>
            <a:ext cx="5600700" cy="304213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407987" y="109181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DUPLICATION RATE HISTOGRAM FOR BLOOD</a:t>
            </a:r>
            <a:endParaRPr lang="en-GB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442572" y="136477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DUPLICATION RATE HISTOGRAM FOR DBS</a:t>
            </a:r>
            <a:endParaRPr lang="en-GB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394338" y="3469943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MAPPING QUALITY HISTOGRAM FOR BLOOD</a:t>
            </a:r>
            <a:endParaRPr lang="en-GB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435177" y="3469944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MAPPING QUALITY HISTOGRAM FOR DBS</a:t>
            </a:r>
            <a:endParaRPr lang="en-GB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68408" y="83836"/>
            <a:ext cx="714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439791" y="114613"/>
            <a:ext cx="820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52477" y="3499580"/>
            <a:ext cx="725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421265" y="3485932"/>
            <a:ext cx="79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B-10120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687410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Statistical output of Data for barcodes captured by 904 probes</a:t>
            </a:r>
            <a:endParaRPr lang="en-US" sz="2800" dirty="0"/>
          </a:p>
        </p:txBody>
      </p:sp>
      <p:graphicFrame>
        <p:nvGraphicFramePr>
          <p:cNvPr id="7" name="Content Placeholder 6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51373281"/>
              </p:ext>
            </p:extLst>
          </p:nvPr>
        </p:nvGraphicFramePr>
        <p:xfrm>
          <a:off x="999745" y="1766758"/>
          <a:ext cx="10192509" cy="4512945"/>
        </p:xfrm>
        <a:graphic>
          <a:graphicData uri="http://schemas.openxmlformats.org/drawingml/2006/table">
            <a:tbl>
              <a:tblPr/>
              <a:tblGrid>
                <a:gridCol w="2532808">
                  <a:extLst>
                    <a:ext uri="{9D8B030D-6E8A-4147-A177-3AD203B41FA5}">
                      <a16:colId xmlns:a16="http://schemas.microsoft.com/office/drawing/2014/main" val="1561101632"/>
                    </a:ext>
                  </a:extLst>
                </a:gridCol>
                <a:gridCol w="2594085">
                  <a:extLst>
                    <a:ext uri="{9D8B030D-6E8A-4147-A177-3AD203B41FA5}">
                      <a16:colId xmlns:a16="http://schemas.microsoft.com/office/drawing/2014/main" val="692832216"/>
                    </a:ext>
                  </a:extLst>
                </a:gridCol>
                <a:gridCol w="2532808">
                  <a:extLst>
                    <a:ext uri="{9D8B030D-6E8A-4147-A177-3AD203B41FA5}">
                      <a16:colId xmlns:a16="http://schemas.microsoft.com/office/drawing/2014/main" val="2177867919"/>
                    </a:ext>
                  </a:extLst>
                </a:gridCol>
                <a:gridCol w="2532808">
                  <a:extLst>
                    <a:ext uri="{9D8B030D-6E8A-4147-A177-3AD203B41FA5}">
                      <a16:colId xmlns:a16="http://schemas.microsoft.com/office/drawing/2014/main" val="396776142"/>
                    </a:ext>
                  </a:extLst>
                </a:gridCol>
              </a:tblGrid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nually extracted DNA from blood (Data for Barcodes capture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4598243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7303558"/>
                  </a:ext>
                </a:extLst>
              </a:tr>
              <a:tr h="54613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percentage of  Duplicate dat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6776113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.D.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6904594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 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. captur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485471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 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. captur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3372750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7829614"/>
                  </a:ext>
                </a:extLst>
              </a:tr>
              <a:tr h="546135"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S DNA (Data 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</a:t>
                      </a:r>
                      <a:r>
                        <a:rPr lang="en-US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rcodes </a:t>
                      </a: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ptur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1697996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163905"/>
                  </a:ext>
                </a:extLst>
              </a:tr>
              <a:tr h="54613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percentage of  Duplicate dat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3360763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.D.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2503899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 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. captur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3402630"/>
                  </a:ext>
                </a:extLst>
              </a:tr>
              <a:tr h="2777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 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. captur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88413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705601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41916159"/>
              </p:ext>
            </p:extLst>
          </p:nvPr>
        </p:nvGraphicFramePr>
        <p:xfrm>
          <a:off x="341194" y="436728"/>
          <a:ext cx="11750722" cy="59231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18518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659340" cy="481036"/>
          </a:xfrm>
        </p:spPr>
        <p:txBody>
          <a:bodyPr>
            <a:noAutofit/>
          </a:bodyPr>
          <a:lstStyle/>
          <a:p>
            <a:r>
              <a:rPr lang="en-US" sz="2400" dirty="0" smtClean="0"/>
              <a:t>Conclusion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9100" y="1187354"/>
            <a:ext cx="11353800" cy="4935017"/>
          </a:xfrm>
        </p:spPr>
        <p:txBody>
          <a:bodyPr>
            <a:normAutofit/>
          </a:bodyPr>
          <a:lstStyle/>
          <a:p>
            <a:r>
              <a:rPr lang="en-US" sz="2400" dirty="0" smtClean="0"/>
              <a:t>Duplication rate was 10% more in DBS as compared to manually extracted DNA</a:t>
            </a:r>
          </a:p>
          <a:p>
            <a:r>
              <a:rPr lang="en-US" sz="2400" dirty="0" smtClean="0"/>
              <a:t> The average unique molecules captured by DBS is 160 and by manually extracted was 258. Thus there was 40% less unique molecule captured by DBS </a:t>
            </a:r>
          </a:p>
          <a:p>
            <a:r>
              <a:rPr lang="en-US" sz="2400" dirty="0" smtClean="0"/>
              <a:t>The variants previously identified by manually extracted DNA were accurately detected using DBS</a:t>
            </a:r>
          </a:p>
          <a:p>
            <a:r>
              <a:rPr lang="en-US" sz="2400" dirty="0" smtClean="0"/>
              <a:t>To conclude, DBS method for DNA extraction can be used for future </a:t>
            </a:r>
            <a:r>
              <a:rPr lang="en-US" sz="2400" dirty="0" err="1" smtClean="0"/>
              <a:t>smMIP</a:t>
            </a:r>
            <a:r>
              <a:rPr lang="en-US" sz="2400" dirty="0"/>
              <a:t>-</a:t>
            </a:r>
            <a:r>
              <a:rPr lang="en-US" sz="2400" dirty="0" smtClean="0"/>
              <a:t>NGS studies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91139787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735774" y="3013501"/>
            <a:ext cx="33982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 smtClean="0"/>
              <a:t>Thank You</a:t>
            </a:r>
            <a:endParaRPr lang="en-US" sz="4800" dirty="0"/>
          </a:p>
        </p:txBody>
      </p:sp>
    </p:spTree>
    <p:extLst>
      <p:ext uri="{BB962C8B-B14F-4D97-AF65-F5344CB8AC3E}">
        <p14:creationId xmlns:p14="http://schemas.microsoft.com/office/powerpoint/2010/main" val="2205016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5267" y="545912"/>
            <a:ext cx="4634780" cy="573206"/>
          </a:xfrm>
        </p:spPr>
        <p:txBody>
          <a:bodyPr>
            <a:normAutofit/>
          </a:bodyPr>
          <a:lstStyle/>
          <a:p>
            <a:r>
              <a:rPr lang="en-US" sz="2400" b="1" u="sng" dirty="0" smtClean="0"/>
              <a:t>Assay details </a:t>
            </a:r>
            <a:endParaRPr lang="en-US" sz="2400" b="1" u="sng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9835" y="1253330"/>
            <a:ext cx="11008057" cy="5256651"/>
          </a:xfrm>
        </p:spPr>
        <p:txBody>
          <a:bodyPr>
            <a:normAutofit/>
          </a:bodyPr>
          <a:lstStyle/>
          <a:p>
            <a:pPr>
              <a:buFont typeface="Wingdings" panose="05000000000000000000" pitchFamily="2" charset="2"/>
              <a:buChar char="Ø"/>
            </a:pPr>
            <a:endParaRPr lang="en-US" sz="2400" dirty="0" smtClean="0"/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The </a:t>
            </a:r>
            <a:r>
              <a:rPr lang="en-US" sz="2400" dirty="0"/>
              <a:t>samples taken for comparative study was from lysosomal storage disorder (LSD), </a:t>
            </a:r>
            <a:r>
              <a:rPr lang="en-US" sz="2400" dirty="0" err="1"/>
              <a:t>Pompe</a:t>
            </a:r>
            <a:r>
              <a:rPr lang="en-US" sz="2400" dirty="0"/>
              <a:t> disease, </a:t>
            </a:r>
            <a:r>
              <a:rPr lang="en-US" sz="2400" dirty="0" err="1"/>
              <a:t>Fabry</a:t>
            </a:r>
            <a:r>
              <a:rPr lang="en-US" sz="2400" dirty="0"/>
              <a:t> Disease and </a:t>
            </a:r>
            <a:r>
              <a:rPr lang="en-US" sz="2400" dirty="0" err="1"/>
              <a:t>Gaucher</a:t>
            </a:r>
            <a:r>
              <a:rPr lang="en-US" sz="2400" dirty="0"/>
              <a:t> Disease </a:t>
            </a:r>
            <a:endParaRPr lang="en-US" sz="2400" dirty="0" smtClean="0"/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The Dried Blood Spot (DBS) DNA and Manually extracted DNA from blood were subjected to </a:t>
            </a:r>
            <a:r>
              <a:rPr lang="en-US" sz="2400" dirty="0" err="1" smtClean="0"/>
              <a:t>smMIP</a:t>
            </a:r>
            <a:r>
              <a:rPr lang="en-US" sz="2400" dirty="0" smtClean="0"/>
              <a:t>-NGS assay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/>
              <a:t>Aim and Objective of the study was to determine the number of unique molecules with less input of the DNA sample </a:t>
            </a:r>
            <a:r>
              <a:rPr lang="en-US" sz="2400" dirty="0" smtClean="0"/>
              <a:t>obtained from DBS in comparison to manually extracted blood DNA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Input DNA for Manually extracted DNA was 100ng and for DBS DNA was around 20ng 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All other criteria for both the setup was same </a:t>
            </a:r>
          </a:p>
        </p:txBody>
      </p:sp>
    </p:spTree>
    <p:extLst>
      <p:ext uri="{BB962C8B-B14F-4D97-AF65-F5344CB8AC3E}">
        <p14:creationId xmlns:p14="http://schemas.microsoft.com/office/powerpoint/2010/main" val="2138408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1212" y="78520"/>
            <a:ext cx="7568821" cy="453741"/>
          </a:xfrm>
          <a:solidFill>
            <a:srgbClr val="92D050"/>
          </a:solidFill>
        </p:spPr>
        <p:txBody>
          <a:bodyPr>
            <a:normAutofit fontScale="90000"/>
          </a:bodyPr>
          <a:lstStyle/>
          <a:p>
            <a:r>
              <a:rPr lang="en-IN" sz="2000" b="1" dirty="0" smtClean="0"/>
              <a:t>S-193: POMPE sample comparison with Manual extracted DNA from Blood Vs DBS </a:t>
            </a:r>
            <a:endParaRPr lang="en-GB" sz="2000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4249453"/>
              </p:ext>
            </p:extLst>
          </p:nvPr>
        </p:nvGraphicFramePr>
        <p:xfrm>
          <a:off x="425358" y="627797"/>
          <a:ext cx="5090616" cy="4819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1191909501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773783507"/>
                    </a:ext>
                  </a:extLst>
                </a:gridCol>
              </a:tblGrid>
              <a:tr h="541980"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INSIDE</a:t>
                      </a:r>
                      <a:r>
                        <a:rPr lang="en-IN" baseline="0" dirty="0" smtClean="0"/>
                        <a:t> OF REGION </a:t>
                      </a:r>
                      <a:br>
                        <a:rPr lang="en-IN" baseline="0" dirty="0" smtClean="0"/>
                      </a:br>
                      <a:r>
                        <a:rPr lang="en-IN" baseline="0" dirty="0" smtClean="0"/>
                        <a:t>(Manual Extraction by Blood)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OUTPUT 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6722780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umber of reads (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side of regions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53,239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6349091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apped</a:t>
                      </a:r>
                      <a:r>
                        <a:rPr lang="en-IN" sz="1600" baseline="0" dirty="0" smtClean="0"/>
                        <a:t> read (inside of region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36,807 / 96.37%</a:t>
                      </a:r>
                      <a:endParaRPr lang="en-GB" sz="1600" dirty="0" smtClean="0"/>
                    </a:p>
                    <a:p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291498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verlapping read pairs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17,256 / 95.87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78193346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uplicated reads (flagged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1,017 / 46.02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65354341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C Percentage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0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2939891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verage (inside of regions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09.6948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13008199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Mapping Quality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8.6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0681219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1097848"/>
              </p:ext>
            </p:extLst>
          </p:nvPr>
        </p:nvGraphicFramePr>
        <p:xfrm>
          <a:off x="6191534" y="649305"/>
          <a:ext cx="5163404" cy="477849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81702">
                  <a:extLst>
                    <a:ext uri="{9D8B030D-6E8A-4147-A177-3AD203B41FA5}">
                      <a16:colId xmlns:a16="http://schemas.microsoft.com/office/drawing/2014/main" val="1191909501"/>
                    </a:ext>
                  </a:extLst>
                </a:gridCol>
                <a:gridCol w="2581702">
                  <a:extLst>
                    <a:ext uri="{9D8B030D-6E8A-4147-A177-3AD203B41FA5}">
                      <a16:colId xmlns:a16="http://schemas.microsoft.com/office/drawing/2014/main" val="773783507"/>
                    </a:ext>
                  </a:extLst>
                </a:gridCol>
              </a:tblGrid>
              <a:tr h="78310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dirty="0" smtClean="0"/>
                        <a:t>INSIDE</a:t>
                      </a:r>
                      <a:r>
                        <a:rPr lang="en-IN" baseline="0" dirty="0" smtClean="0"/>
                        <a:t> OF REGION </a:t>
                      </a:r>
                      <a:br>
                        <a:rPr lang="en-IN" baseline="0" dirty="0" smtClean="0"/>
                      </a:br>
                      <a:r>
                        <a:rPr lang="en-IN" baseline="0" dirty="0" smtClean="0"/>
                        <a:t>(DBS)</a:t>
                      </a:r>
                      <a:endParaRPr lang="en-GB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OUTPUT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6722780"/>
                  </a:ext>
                </a:extLst>
              </a:tr>
              <a:tr h="592972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umber of reads (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side of regions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16,741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6349091"/>
                  </a:ext>
                </a:extLst>
              </a:tr>
              <a:tr h="592972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apped</a:t>
                      </a:r>
                      <a:r>
                        <a:rPr lang="en-IN" sz="1600" baseline="0" dirty="0" smtClean="0"/>
                        <a:t> read (inside of region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05,098 / 97.21%</a:t>
                      </a:r>
                      <a:endParaRPr lang="en-GB" sz="1600" dirty="0" smtClean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291498"/>
                  </a:ext>
                </a:extLst>
              </a:tr>
              <a:tr h="554118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verlapping read pairs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1,753 / 96.82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78193346"/>
                  </a:ext>
                </a:extLst>
              </a:tr>
              <a:tr h="554118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uplicated reads (flagged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8,863 / 51.56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65354341"/>
                  </a:ext>
                </a:extLst>
              </a:tr>
              <a:tr h="554118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C Percentage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3.04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2939891"/>
                  </a:ext>
                </a:extLst>
              </a:tr>
              <a:tr h="592972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verage (inside of regions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54.1372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13008199"/>
                  </a:ext>
                </a:extLst>
              </a:tr>
              <a:tr h="554118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Mapping Quality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8.7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0681219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2464600"/>
              </p:ext>
            </p:extLst>
          </p:nvPr>
        </p:nvGraphicFramePr>
        <p:xfrm>
          <a:off x="425358" y="5438897"/>
          <a:ext cx="5090616" cy="579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453741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ismatches and indels (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General error rate</a:t>
                      </a:r>
                      <a:r>
                        <a:rPr lang="en-IN" sz="1600" dirty="0" smtClean="0"/>
                        <a:t>)</a:t>
                      </a:r>
                      <a:endParaRPr lang="en-GB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0.44%</a:t>
                      </a:r>
                      <a:endParaRPr lang="en-GB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825889"/>
              </p:ext>
            </p:extLst>
          </p:nvPr>
        </p:nvGraphicFramePr>
        <p:xfrm>
          <a:off x="6191534" y="5435060"/>
          <a:ext cx="5163404" cy="579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81702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81702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538677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ismatches and indels (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General error rate</a:t>
                      </a:r>
                      <a:r>
                        <a:rPr lang="en-IN" sz="1600" dirty="0" smtClean="0"/>
                        <a:t>)</a:t>
                      </a:r>
                      <a:endParaRPr lang="en-GB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0.39%</a:t>
                      </a:r>
                      <a:endParaRPr lang="en-GB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404188"/>
              </p:ext>
            </p:extLst>
          </p:nvPr>
        </p:nvGraphicFramePr>
        <p:xfrm>
          <a:off x="425358" y="6018017"/>
          <a:ext cx="5090616" cy="4537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453741">
                <a:tc>
                  <a:txBody>
                    <a:bodyPr/>
                    <a:lstStyle/>
                    <a:p>
                      <a:r>
                        <a:rPr lang="en-IN" sz="1600" baseline="0" dirty="0" smtClean="0"/>
                        <a:t>VARIANT DEPTH</a:t>
                      </a:r>
                      <a:endParaRPr lang="en-GB" sz="1600" dirty="0"/>
                    </a:p>
                  </a:txBody>
                  <a:tcPr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 smtClean="0"/>
                        <a:t>146x</a:t>
                      </a:r>
                      <a:endParaRPr lang="en-GB" sz="1600" dirty="0"/>
                    </a:p>
                  </a:txBody>
                  <a:tcPr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9797209"/>
              </p:ext>
            </p:extLst>
          </p:nvPr>
        </p:nvGraphicFramePr>
        <p:xfrm>
          <a:off x="6191534" y="6007795"/>
          <a:ext cx="5163404" cy="4537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81702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81702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453741">
                <a:tc>
                  <a:txBody>
                    <a:bodyPr/>
                    <a:lstStyle/>
                    <a:p>
                      <a:r>
                        <a:rPr lang="en-IN" sz="1600" baseline="0" dirty="0" smtClean="0"/>
                        <a:t>VARIANT DEPTH</a:t>
                      </a:r>
                      <a:endParaRPr lang="en-GB" sz="1600" dirty="0"/>
                    </a:p>
                  </a:txBody>
                  <a:tcPr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 smtClean="0"/>
                        <a:t>199x</a:t>
                      </a:r>
                      <a:endParaRPr lang="en-GB" sz="1600" dirty="0"/>
                    </a:p>
                  </a:txBody>
                  <a:tcPr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426701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182" y="0"/>
            <a:ext cx="5810250" cy="3429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18829" y="44354"/>
            <a:ext cx="5743575" cy="3429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180" y="3429000"/>
            <a:ext cx="5787504" cy="304653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18830" y="3429000"/>
            <a:ext cx="5743575" cy="29823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528547" y="124779"/>
            <a:ext cx="3411941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BLOOD </a:t>
            </a:r>
            <a:endParaRPr lang="en-GB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952947" y="99433"/>
            <a:ext cx="2695787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DBS </a:t>
            </a:r>
            <a:endParaRPr lang="en-GB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407987" y="3525359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BLOOD (0-50X)</a:t>
            </a:r>
            <a:endParaRPr lang="en-GB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7456236" y="3582223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DBS (0-50X)</a:t>
            </a:r>
            <a:endParaRPr lang="en-GB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131928" y="111132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303311" y="141909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15997" y="3567820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325729" y="3567820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  <p:sp>
        <p:nvSpPr>
          <p:cNvPr id="18" name="Rectangle 17"/>
          <p:cNvSpPr/>
          <p:nvPr/>
        </p:nvSpPr>
        <p:spPr>
          <a:xfrm>
            <a:off x="4408229" y="528092"/>
            <a:ext cx="218364" cy="278831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10331371" y="514444"/>
            <a:ext cx="218364" cy="278831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40810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092" y="150125"/>
            <a:ext cx="5638800" cy="313898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4642" y="150125"/>
            <a:ext cx="5512558" cy="313898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4092" y="3429001"/>
            <a:ext cx="5638800" cy="304554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74642" y="3429000"/>
            <a:ext cx="5512558" cy="307504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407987" y="163773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DUPLICATION RATE HISTOGRAM FOR BLOOD</a:t>
            </a:r>
            <a:endParaRPr lang="en-GB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442572" y="136477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DUPLICATION RATE HISTOGRAM FOR DBS</a:t>
            </a:r>
            <a:endParaRPr lang="en-GB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394338" y="3469943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MAPPING QUALITY HISTOGRAM FOR BLOOD</a:t>
            </a:r>
            <a:endParaRPr lang="en-GB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435177" y="3469944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MAPPING QUALITY HISTOGRAM FOR DBS</a:t>
            </a:r>
            <a:endParaRPr lang="en-GB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357903" y="155557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356431" y="3471065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74092" y="3467303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95041" y="180903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193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677848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07692" y="174056"/>
            <a:ext cx="7568821" cy="453741"/>
          </a:xfrm>
          <a:solidFill>
            <a:srgbClr val="92D050"/>
          </a:solidFill>
        </p:spPr>
        <p:txBody>
          <a:bodyPr>
            <a:normAutofit/>
          </a:bodyPr>
          <a:lstStyle/>
          <a:p>
            <a:r>
              <a:rPr lang="en-IN" sz="1800" b="1" dirty="0" smtClean="0"/>
              <a:t>S-203: FABRY sample comparison with Manual extracted DNA from Blood Vs DBS </a:t>
            </a:r>
            <a:endParaRPr lang="en-GB" sz="1800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9487494"/>
              </p:ext>
            </p:extLst>
          </p:nvPr>
        </p:nvGraphicFramePr>
        <p:xfrm>
          <a:off x="425358" y="651057"/>
          <a:ext cx="5090616" cy="4819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1191909501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773783507"/>
                    </a:ext>
                  </a:extLst>
                </a:gridCol>
              </a:tblGrid>
              <a:tr h="541980"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INSIDE</a:t>
                      </a:r>
                      <a:r>
                        <a:rPr lang="en-IN" baseline="0" dirty="0" smtClean="0"/>
                        <a:t> OF REGION </a:t>
                      </a:r>
                      <a:br>
                        <a:rPr lang="en-IN" baseline="0" dirty="0" smtClean="0"/>
                      </a:br>
                      <a:r>
                        <a:rPr lang="en-IN" baseline="0" dirty="0" smtClean="0"/>
                        <a:t>(Manual Extraction by Blood)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OUTPUT 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6722780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umber of reads (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side of regions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66,884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6349091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apped</a:t>
                      </a:r>
                      <a:r>
                        <a:rPr lang="en-IN" sz="1600" baseline="0" dirty="0" smtClean="0"/>
                        <a:t> read (inside of region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54,696 / 96.68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291498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verlapping read pairs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76,487 / 96.21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78193346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uplicated reads (flagged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74,084 / 49.08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65354341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C Percentage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0.46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2939891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verage (inside of regions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72.9778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13008199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Mapping Quality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8.7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0681219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7870528"/>
              </p:ext>
            </p:extLst>
          </p:nvPr>
        </p:nvGraphicFramePr>
        <p:xfrm>
          <a:off x="6277970" y="651060"/>
          <a:ext cx="5340824" cy="479842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70412">
                  <a:extLst>
                    <a:ext uri="{9D8B030D-6E8A-4147-A177-3AD203B41FA5}">
                      <a16:colId xmlns:a16="http://schemas.microsoft.com/office/drawing/2014/main" val="1191909501"/>
                    </a:ext>
                  </a:extLst>
                </a:gridCol>
                <a:gridCol w="2670412">
                  <a:extLst>
                    <a:ext uri="{9D8B030D-6E8A-4147-A177-3AD203B41FA5}">
                      <a16:colId xmlns:a16="http://schemas.microsoft.com/office/drawing/2014/main" val="773783507"/>
                    </a:ext>
                  </a:extLst>
                </a:gridCol>
              </a:tblGrid>
              <a:tr h="78313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dirty="0" smtClean="0"/>
                        <a:t>INSIDE</a:t>
                      </a:r>
                      <a:r>
                        <a:rPr lang="en-IN" baseline="0" dirty="0" smtClean="0"/>
                        <a:t> OF REGION </a:t>
                      </a:r>
                      <a:br>
                        <a:rPr lang="en-IN" baseline="0" dirty="0" smtClean="0"/>
                      </a:br>
                      <a:r>
                        <a:rPr lang="en-IN" baseline="0" dirty="0" smtClean="0"/>
                        <a:t>(DBS)</a:t>
                      </a:r>
                      <a:endParaRPr lang="en-GB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OUTPUT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6722780"/>
                  </a:ext>
                </a:extLst>
              </a:tr>
              <a:tr h="599585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umber of reads (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side of regions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92,655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6349091"/>
                  </a:ext>
                </a:extLst>
              </a:tr>
              <a:tr h="599585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apped</a:t>
                      </a:r>
                      <a:r>
                        <a:rPr lang="en-IN" sz="1600" baseline="0" dirty="0" smtClean="0"/>
                        <a:t> read (inside of region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7,535 / 97.34%</a:t>
                      </a:r>
                      <a:endParaRPr lang="en-GB" sz="1600" dirty="0" smtClean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291498"/>
                  </a:ext>
                </a:extLst>
              </a:tr>
              <a:tr h="554135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verlapping read pairs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3,349 / 96.91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78193346"/>
                  </a:ext>
                </a:extLst>
              </a:tr>
              <a:tr h="554135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uplicated reads (flagged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4,265 / 50.27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65354341"/>
                  </a:ext>
                </a:extLst>
              </a:tr>
              <a:tr h="554135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C Percentage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3.8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2939891"/>
                  </a:ext>
                </a:extLst>
              </a:tr>
              <a:tr h="599585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verage (inside of regions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01.5849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13008199"/>
                  </a:ext>
                </a:extLst>
              </a:tr>
              <a:tr h="554135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Mapping Quality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8.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0681219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2689586"/>
              </p:ext>
            </p:extLst>
          </p:nvPr>
        </p:nvGraphicFramePr>
        <p:xfrm>
          <a:off x="425358" y="5485488"/>
          <a:ext cx="5090616" cy="579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274322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ismatches and indels (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General error rate</a:t>
                      </a:r>
                      <a:r>
                        <a:rPr lang="en-IN" sz="1600" dirty="0" smtClean="0"/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0.46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3835133"/>
              </p:ext>
            </p:extLst>
          </p:nvPr>
        </p:nvGraphicFramePr>
        <p:xfrm>
          <a:off x="6264322" y="5464233"/>
          <a:ext cx="5354472" cy="579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77236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677236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538677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ismatches and indels (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General error rate</a:t>
                      </a:r>
                      <a:r>
                        <a:rPr lang="en-IN" sz="1600" dirty="0" smtClean="0"/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0.4</a:t>
                      </a:r>
                      <a:r>
                        <a:rPr lang="en-GB" sz="18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%</a:t>
                      </a:r>
                      <a:endParaRPr lang="en-GB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1994843"/>
              </p:ext>
            </p:extLst>
          </p:nvPr>
        </p:nvGraphicFramePr>
        <p:xfrm>
          <a:off x="425358" y="6013857"/>
          <a:ext cx="5090616" cy="4537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453741">
                <a:tc>
                  <a:txBody>
                    <a:bodyPr/>
                    <a:lstStyle/>
                    <a:p>
                      <a:r>
                        <a:rPr lang="en-IN" sz="1600" baseline="0" dirty="0" smtClean="0"/>
                        <a:t>VARIANT DEPTH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 smtClean="0"/>
                        <a:t>26x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5872689"/>
              </p:ext>
            </p:extLst>
          </p:nvPr>
        </p:nvGraphicFramePr>
        <p:xfrm>
          <a:off x="6255242" y="6003581"/>
          <a:ext cx="5363552" cy="4537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81776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681776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453741">
                <a:tc>
                  <a:txBody>
                    <a:bodyPr/>
                    <a:lstStyle/>
                    <a:p>
                      <a:r>
                        <a:rPr lang="en-IN" sz="1600" baseline="0" dirty="0" smtClean="0"/>
                        <a:t>VARIANT DEPTH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 smtClean="0"/>
                        <a:t>20x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773863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789" y="155671"/>
            <a:ext cx="5689340" cy="317438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437" y="3429001"/>
            <a:ext cx="5675692" cy="294230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37027" y="155671"/>
            <a:ext cx="5677467" cy="317438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37027" y="3497237"/>
            <a:ext cx="5677467" cy="288881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528547" y="124779"/>
            <a:ext cx="3411941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BLOOD </a:t>
            </a:r>
            <a:endParaRPr lang="en-GB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952947" y="99433"/>
            <a:ext cx="2695787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DBS </a:t>
            </a:r>
            <a:endParaRPr lang="en-GB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07987" y="3525359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BLOOD (0-50X)</a:t>
            </a:r>
            <a:endParaRPr lang="en-GB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456236" y="3582223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COVERAGE HISTOGRAM FOR DBS (0-50X)</a:t>
            </a:r>
            <a:endParaRPr lang="en-GB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7464" y="111132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398847" y="141909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11533" y="3567820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421265" y="3567820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  <p:sp>
        <p:nvSpPr>
          <p:cNvPr id="16" name="Rectangle 15"/>
          <p:cNvSpPr/>
          <p:nvPr/>
        </p:nvSpPr>
        <p:spPr>
          <a:xfrm>
            <a:off x="4135269" y="473500"/>
            <a:ext cx="218364" cy="278831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/>
          <p:cNvSpPr/>
          <p:nvPr/>
        </p:nvSpPr>
        <p:spPr>
          <a:xfrm>
            <a:off x="10115278" y="516716"/>
            <a:ext cx="218364" cy="278831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647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854" y="68238"/>
            <a:ext cx="5744570" cy="333346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854" y="3429001"/>
            <a:ext cx="5744570" cy="30307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6567" y="68238"/>
            <a:ext cx="5591175" cy="333346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16567" y="3429001"/>
            <a:ext cx="5543550" cy="304554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407987" y="109181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DUPLICATION RATE HISTOGRAM FOR BLOOD</a:t>
            </a:r>
            <a:endParaRPr lang="en-GB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442572" y="136477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DUPLICATION RATE HISTOGRAM FOR DBS</a:t>
            </a:r>
            <a:endParaRPr lang="en-GB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394338" y="3469943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MAPPING QUALITY HISTOGRAM FOR BLOOD</a:t>
            </a:r>
            <a:endParaRPr lang="en-GB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435177" y="3469944"/>
            <a:ext cx="3641683" cy="30777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/>
              <a:t>MAPPING QUALITY HISTOGRAM FOR DBS</a:t>
            </a:r>
            <a:endParaRPr lang="en-GB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68408" y="83836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439791" y="114613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52477" y="3540524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462209" y="3540524"/>
            <a:ext cx="53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/>
              <a:t>S-203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42817732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3290" y="174056"/>
            <a:ext cx="9042780" cy="453741"/>
          </a:xfrm>
          <a:solidFill>
            <a:srgbClr val="92D050"/>
          </a:solidFill>
        </p:spPr>
        <p:txBody>
          <a:bodyPr>
            <a:normAutofit fontScale="90000"/>
          </a:bodyPr>
          <a:lstStyle/>
          <a:p>
            <a:r>
              <a:rPr lang="en-IN" sz="2000" b="1" dirty="0" smtClean="0"/>
              <a:t>B -10120: GAUCHER DISEASE sample comparison with Manual extracted DNA from Blood Vs DBS </a:t>
            </a:r>
            <a:endParaRPr lang="en-GB" sz="2000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4521225"/>
              </p:ext>
            </p:extLst>
          </p:nvPr>
        </p:nvGraphicFramePr>
        <p:xfrm>
          <a:off x="425358" y="651055"/>
          <a:ext cx="5090616" cy="4819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1191909501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773783507"/>
                    </a:ext>
                  </a:extLst>
                </a:gridCol>
              </a:tblGrid>
              <a:tr h="541980"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INSIDE</a:t>
                      </a:r>
                      <a:r>
                        <a:rPr lang="en-IN" baseline="0" dirty="0" smtClean="0"/>
                        <a:t> OF REGION </a:t>
                      </a:r>
                      <a:br>
                        <a:rPr lang="en-IN" baseline="0" dirty="0" smtClean="0"/>
                      </a:br>
                      <a:r>
                        <a:rPr lang="en-IN" baseline="0" dirty="0" smtClean="0"/>
                        <a:t>(Manual Extraction by Blood)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OUTPUT 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6722780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umber of reads (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side of regions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77,795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6349091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apped</a:t>
                      </a:r>
                      <a:r>
                        <a:rPr lang="en-IN" sz="1600" baseline="0" dirty="0" smtClean="0"/>
                        <a:t> read (inside of region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69,002 / 97.67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291498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verlapping read pairs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3,719 / 97.26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78193346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uplicated reads (flagged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70,259 / 46.14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65354341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C Percentage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0.21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2939891"/>
                  </a:ext>
                </a:extLst>
              </a:tr>
              <a:tr h="553684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verage (inside of regions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01.6601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13008199"/>
                  </a:ext>
                </a:extLst>
              </a:tr>
              <a:tr h="541980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Mapping Quality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8.6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0681219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0044738"/>
              </p:ext>
            </p:extLst>
          </p:nvPr>
        </p:nvGraphicFramePr>
        <p:xfrm>
          <a:off x="6096000" y="656238"/>
          <a:ext cx="5354472" cy="47511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77236">
                  <a:extLst>
                    <a:ext uri="{9D8B030D-6E8A-4147-A177-3AD203B41FA5}">
                      <a16:colId xmlns:a16="http://schemas.microsoft.com/office/drawing/2014/main" val="1191909501"/>
                    </a:ext>
                  </a:extLst>
                </a:gridCol>
                <a:gridCol w="2677236">
                  <a:extLst>
                    <a:ext uri="{9D8B030D-6E8A-4147-A177-3AD203B41FA5}">
                      <a16:colId xmlns:a16="http://schemas.microsoft.com/office/drawing/2014/main" val="773783507"/>
                    </a:ext>
                  </a:extLst>
                </a:gridCol>
              </a:tblGrid>
              <a:tr h="77816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dirty="0" smtClean="0"/>
                        <a:t>INSIDE</a:t>
                      </a:r>
                      <a:r>
                        <a:rPr lang="en-IN" baseline="0" dirty="0" smtClean="0"/>
                        <a:t> OF REGION </a:t>
                      </a:r>
                      <a:br>
                        <a:rPr lang="en-IN" baseline="0" dirty="0" smtClean="0"/>
                      </a:br>
                      <a:r>
                        <a:rPr lang="en-IN" baseline="0" dirty="0" smtClean="0"/>
                        <a:t>(DBS)</a:t>
                      </a:r>
                      <a:endParaRPr lang="en-GB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 smtClean="0"/>
                        <a:t>OUTPUT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6722780"/>
                  </a:ext>
                </a:extLst>
              </a:tr>
              <a:tr h="599326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umber of reads (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side of regions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8,746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6349091"/>
                  </a:ext>
                </a:extLst>
              </a:tr>
              <a:tr h="599326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apped</a:t>
                      </a:r>
                      <a:r>
                        <a:rPr lang="en-IN" sz="1600" baseline="0" dirty="0" smtClean="0"/>
                        <a:t> read (inside of region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4,443 / 97.72%</a:t>
                      </a:r>
                      <a:endParaRPr lang="en-GB" sz="1600" dirty="0" smtClean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291498"/>
                  </a:ext>
                </a:extLst>
              </a:tr>
              <a:tr h="523104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verlapping read pairs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1,935 / 97.42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78193346"/>
                  </a:ext>
                </a:extLst>
              </a:tr>
              <a:tr h="550621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uplicated reads (flagged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7,029 / 47.18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65354341"/>
                  </a:ext>
                </a:extLst>
              </a:tr>
              <a:tr h="550621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C Percentage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2.62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2939891"/>
                  </a:ext>
                </a:extLst>
              </a:tr>
              <a:tr h="599326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</a:t>
                      </a:r>
                      <a:r>
                        <a:rPr lang="en-GB" sz="1600" b="1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verage (inside of regions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97.6513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13008199"/>
                  </a:ext>
                </a:extLst>
              </a:tr>
              <a:tr h="550621"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 Mapping Quality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8.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0681219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7122607"/>
              </p:ext>
            </p:extLst>
          </p:nvPr>
        </p:nvGraphicFramePr>
        <p:xfrm>
          <a:off x="425358" y="5432664"/>
          <a:ext cx="5090616" cy="579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274322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ismatches and indels (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General error rate</a:t>
                      </a:r>
                      <a:r>
                        <a:rPr lang="en-IN" sz="1600" dirty="0" smtClean="0"/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0.4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2616293"/>
              </p:ext>
            </p:extLst>
          </p:nvPr>
        </p:nvGraphicFramePr>
        <p:xfrm>
          <a:off x="6096000" y="5399200"/>
          <a:ext cx="5354472" cy="579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77236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677236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538677">
                <a:tc>
                  <a:txBody>
                    <a:bodyPr/>
                    <a:lstStyle/>
                    <a:p>
                      <a:r>
                        <a:rPr lang="en-IN" sz="1600" dirty="0" smtClean="0"/>
                        <a:t>Mismatches and indels (</a:t>
                      </a:r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General error rate</a:t>
                      </a:r>
                      <a:r>
                        <a:rPr lang="en-IN" sz="1600" dirty="0" smtClean="0"/>
                        <a:t>)</a:t>
                      </a:r>
                      <a:endParaRPr lang="en-GB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600" b="0" i="0" u="none" strike="noStrike" kern="1200" baseline="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0.34%</a:t>
                      </a:r>
                      <a:endParaRPr lang="en-GB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8332788"/>
              </p:ext>
            </p:extLst>
          </p:nvPr>
        </p:nvGraphicFramePr>
        <p:xfrm>
          <a:off x="425358" y="5984361"/>
          <a:ext cx="5090616" cy="4537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5308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545308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453741">
                <a:tc>
                  <a:txBody>
                    <a:bodyPr/>
                    <a:lstStyle/>
                    <a:p>
                      <a:r>
                        <a:rPr lang="en-IN" sz="1600" baseline="0" dirty="0" smtClean="0"/>
                        <a:t>VARIANT DEPTH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 smtClean="0"/>
                        <a:t>349x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5106931"/>
              </p:ext>
            </p:extLst>
          </p:nvPr>
        </p:nvGraphicFramePr>
        <p:xfrm>
          <a:off x="6096000" y="5970712"/>
          <a:ext cx="5354472" cy="453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77236">
                  <a:extLst>
                    <a:ext uri="{9D8B030D-6E8A-4147-A177-3AD203B41FA5}">
                      <a16:colId xmlns:a16="http://schemas.microsoft.com/office/drawing/2014/main" val="2832720463"/>
                    </a:ext>
                  </a:extLst>
                </a:gridCol>
                <a:gridCol w="2677236">
                  <a:extLst>
                    <a:ext uri="{9D8B030D-6E8A-4147-A177-3AD203B41FA5}">
                      <a16:colId xmlns:a16="http://schemas.microsoft.com/office/drawing/2014/main" val="2549697098"/>
                    </a:ext>
                  </a:extLst>
                </a:gridCol>
              </a:tblGrid>
              <a:tr h="453742">
                <a:tc>
                  <a:txBody>
                    <a:bodyPr/>
                    <a:lstStyle/>
                    <a:p>
                      <a:r>
                        <a:rPr lang="en-IN" sz="1600" baseline="0" dirty="0" smtClean="0"/>
                        <a:t>VARIANT DEPTH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 smtClean="0"/>
                        <a:t>297x</a:t>
                      </a:r>
                      <a:endParaRPr lang="en-GB" sz="1600" dirty="0"/>
                    </a:p>
                  </a:txBody>
                  <a:tcPr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3263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55978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</TotalTime>
  <Words>934</Words>
  <Application>Microsoft Office PowerPoint</Application>
  <PresentationFormat>Widescreen</PresentationFormat>
  <Paragraphs>236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5</vt:i4>
      </vt:variant>
    </vt:vector>
  </HeadingPairs>
  <TitlesOfParts>
    <vt:vector size="21" baseType="lpstr">
      <vt:lpstr>Arial</vt:lpstr>
      <vt:lpstr>Calibri</vt:lpstr>
      <vt:lpstr>Calibri Light</vt:lpstr>
      <vt:lpstr>Wingdings</vt:lpstr>
      <vt:lpstr>Office Theme</vt:lpstr>
      <vt:lpstr>Custom Design</vt:lpstr>
      <vt:lpstr>Comparative data for Dried Blood Spot (DBS) extracted DNA and Manual blood extracted DNA </vt:lpstr>
      <vt:lpstr>Assay details </vt:lpstr>
      <vt:lpstr>S-193: POMPE sample comparison with Manual extracted DNA from Blood Vs DBS </vt:lpstr>
      <vt:lpstr>PowerPoint Presentation</vt:lpstr>
      <vt:lpstr>PowerPoint Presentation</vt:lpstr>
      <vt:lpstr>S-203: FABRY sample comparison with Manual extracted DNA from Blood Vs DBS </vt:lpstr>
      <vt:lpstr>PowerPoint Presentation</vt:lpstr>
      <vt:lpstr>PowerPoint Presentation</vt:lpstr>
      <vt:lpstr>B -10120: GAUCHER DISEASE sample comparison with Manual extracted DNA from Blood Vs DBS </vt:lpstr>
      <vt:lpstr>PowerPoint Presentation</vt:lpstr>
      <vt:lpstr>PowerPoint Presentation</vt:lpstr>
      <vt:lpstr>Statistical output of Data for barcodes captured by 904 probes</vt:lpstr>
      <vt:lpstr>PowerPoint Presentation</vt:lpstr>
      <vt:lpstr>Conclusion 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-193 sample comparison with Manual extracted DNA from Blood Vs DBS</dc:title>
  <dc:creator>ADMIN</dc:creator>
  <cp:lastModifiedBy>ADMIN</cp:lastModifiedBy>
  <cp:revision>48</cp:revision>
  <dcterms:created xsi:type="dcterms:W3CDTF">2023-12-15T04:53:30Z</dcterms:created>
  <dcterms:modified xsi:type="dcterms:W3CDTF">2024-02-19T09:54:07Z</dcterms:modified>
</cp:coreProperties>
</file>